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12193588" cy="12193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GB" sz="1200" spc="-1" strike="noStrike">
                <a:solidFill>
                  <a:srgbClr val="000000"/>
                </a:solidFill>
                <a:latin typeface="Aptos"/>
                <a:ea typeface="굴림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ptos"/>
                <a:ea typeface="굴림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886040" y="1142640"/>
            <a:ext cx="3085920" cy="3086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r>
              <a:rPr b="0" lang="en-US" sz="5800" spc="-1" strike="noStrike">
                <a:solidFill>
                  <a:srgbClr val="000000"/>
                </a:solidFill>
                <a:latin typeface="Calibri Light"/>
              </a:rPr>
              <a:t>Click to move the slide</a:t>
            </a: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ptos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GB" sz="1200" spc="-1" strike="noStrike">
                <a:solidFill>
                  <a:srgbClr val="000000"/>
                </a:solidFill>
                <a:latin typeface="Aptos"/>
                <a:ea typeface="굴림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2A77DC24-A249-4697-BBB9-1009059F55BA}" type="slidenum">
              <a:rPr b="0" lang="en-GB" sz="1200" spc="-1" strike="noStrike">
                <a:solidFill>
                  <a:srgbClr val="000000"/>
                </a:solidFill>
                <a:latin typeface="Aptos"/>
                <a:ea typeface="굴림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ldImg"/>
          </p:nvPr>
        </p:nvSpPr>
        <p:spPr>
          <a:xfrm>
            <a:off x="1886040" y="1143000"/>
            <a:ext cx="3085920" cy="3086280"/>
          </a:xfrm>
          <a:prstGeom prst="rect">
            <a:avLst/>
          </a:prstGeom>
          <a:ln w="0">
            <a:noFill/>
          </a:ln>
        </p:spPr>
      </p:sp>
      <p:sp>
        <p:nvSpPr>
          <p:cNvPr id="55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1200" spc="-1" strike="noStrike">
              <a:solidFill>
                <a:srgbClr val="000000"/>
              </a:solidFill>
              <a:latin typeface="Aptos"/>
              <a:ea typeface="굴림"/>
            </a:endParaRPr>
          </a:p>
        </p:txBody>
      </p:sp>
      <p:sp>
        <p:nvSpPr>
          <p:cNvPr id="56" name="Slide Number Placeholder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A23F4263-F779-4D01-A93F-0F87DC848818}" type="slidenum">
              <a:rPr b="0" lang="en-GB" sz="1200" spc="-1" strike="noStrike">
                <a:solidFill>
                  <a:srgbClr val="000000"/>
                </a:solidFill>
                <a:latin typeface="Aptos"/>
                <a:ea typeface="굴림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371FB4-AE28-4DA5-BE07-31F0C1635ED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649440"/>
            <a:ext cx="105156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3244320"/>
            <a:ext cx="105156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7285320"/>
            <a:ext cx="105156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F1DDED-1976-4E14-B3B8-D8F8708A903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649440"/>
            <a:ext cx="105156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3244320"/>
            <a:ext cx="513144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3244320"/>
            <a:ext cx="513144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7285320"/>
            <a:ext cx="513144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7285320"/>
            <a:ext cx="513144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324EF6-28A7-44FF-89F9-12D45FDCC24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649440"/>
            <a:ext cx="105156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3244320"/>
            <a:ext cx="33858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3244320"/>
            <a:ext cx="33858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3244320"/>
            <a:ext cx="33858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7285320"/>
            <a:ext cx="33858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7285320"/>
            <a:ext cx="33858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7285320"/>
            <a:ext cx="33858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A1FB68-9954-48D5-84E6-56711716FCA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649440"/>
            <a:ext cx="105156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3244320"/>
            <a:ext cx="10515600" cy="7736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338"/>
              </a:spcBef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0F858F-3115-40DA-BCD4-FDC87D08F52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649440"/>
            <a:ext cx="105156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3244320"/>
            <a:ext cx="10515600" cy="773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6B4426-C420-46B5-857D-557266A3682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649440"/>
            <a:ext cx="105156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3244320"/>
            <a:ext cx="5131440" cy="773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3244320"/>
            <a:ext cx="5131440" cy="773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016C78-9C3D-4638-BA67-70B856768D1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649440"/>
            <a:ext cx="105156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31D8BA-EBA3-4DC9-9D4B-18C468ED686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649440"/>
            <a:ext cx="10515600" cy="10921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338"/>
              </a:spcBef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10549E-0464-4C82-8F4B-3F6A5B8DD89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649440"/>
            <a:ext cx="105156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3244320"/>
            <a:ext cx="513144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3244320"/>
            <a:ext cx="5131440" cy="773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7285320"/>
            <a:ext cx="513144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D75A00-5F1F-438B-AC25-FDB3A4F3FB5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649440"/>
            <a:ext cx="105156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3244320"/>
            <a:ext cx="5131440" cy="773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3244320"/>
            <a:ext cx="513144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7285320"/>
            <a:ext cx="513144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E873A4-D214-428D-A7FD-9BD690D9B94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649440"/>
            <a:ext cx="105156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3244320"/>
            <a:ext cx="513144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3244320"/>
            <a:ext cx="513144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7285320"/>
            <a:ext cx="105156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719C5C-F0BB-47AF-AEA6-D0985AC3AA5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649440"/>
            <a:ext cx="105156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r>
              <a:rPr b="0" lang="en-US" sz="58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3244320"/>
            <a:ext cx="10515600" cy="773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3120" indent="-303120">
              <a:lnSpc>
                <a:spcPct val="90000"/>
              </a:lnSpc>
              <a:spcBef>
                <a:spcPts val="1338"/>
              </a:spcBef>
              <a:buClr>
                <a:srgbClr val="000000"/>
              </a:buClr>
              <a:buFont typeface="Arial"/>
              <a:buChar char="•"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  <a:p>
            <a:pPr lvl="1" marL="912960" indent="-303480">
              <a:lnSpc>
                <a:spcPct val="90000"/>
              </a:lnSpc>
              <a:spcBef>
                <a:spcPts val="1338"/>
              </a:spcBef>
              <a:buClr>
                <a:srgbClr val="000000"/>
              </a:buClr>
              <a:buFont typeface="Arial"/>
              <a:buChar char="•"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  <a:p>
            <a:pPr lvl="2" marL="1522440" indent="-303120">
              <a:lnSpc>
                <a:spcPct val="90000"/>
              </a:lnSpc>
              <a:spcBef>
                <a:spcPts val="1338"/>
              </a:spcBef>
              <a:buClr>
                <a:srgbClr val="000000"/>
              </a:buClr>
              <a:buFont typeface="Arial"/>
              <a:buChar char="•"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  <a:p>
            <a:pPr lvl="3" marL="2131920" indent="-303120">
              <a:lnSpc>
                <a:spcPct val="90000"/>
              </a:lnSpc>
              <a:spcBef>
                <a:spcPts val="1338"/>
              </a:spcBef>
              <a:buClr>
                <a:srgbClr val="000000"/>
              </a:buClr>
              <a:buFont typeface="Arial"/>
              <a:buChar char="•"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  <a:p>
            <a:pPr lvl="4" marL="2741760" indent="-303480">
              <a:lnSpc>
                <a:spcPct val="90000"/>
              </a:lnSpc>
              <a:spcBef>
                <a:spcPts val="1338"/>
              </a:spcBef>
              <a:buClr>
                <a:srgbClr val="000000"/>
              </a:buClr>
              <a:buFont typeface="Arial"/>
              <a:buChar char="•"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  <a:p>
            <a:pPr lvl="5" marL="2741760" indent="-303480">
              <a:lnSpc>
                <a:spcPct val="90000"/>
              </a:lnSpc>
              <a:spcBef>
                <a:spcPts val="1338"/>
              </a:spcBef>
              <a:buClr>
                <a:srgbClr val="000000"/>
              </a:buClr>
              <a:buFont typeface="Arial"/>
              <a:buChar char="•"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  <a:p>
            <a:pPr lvl="6" marL="2741760" indent="-303480">
              <a:lnSpc>
                <a:spcPct val="90000"/>
              </a:lnSpc>
              <a:spcBef>
                <a:spcPts val="1338"/>
              </a:spcBef>
              <a:buClr>
                <a:srgbClr val="000000"/>
              </a:buClr>
              <a:buFont typeface="Arial"/>
              <a:buChar char="•"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11299680"/>
            <a:ext cx="2743200" cy="649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600" spc="-1" strike="noStrike">
                <a:solidFill>
                  <a:srgbClr val="898989"/>
                </a:solidFill>
                <a:latin typeface="Calibri"/>
                <a:ea typeface="Yu Gothic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ja-JP" sz="1600" spc="-1" strike="noStrike">
                <a:solidFill>
                  <a:srgbClr val="898989"/>
                </a:solidFill>
                <a:latin typeface="Calibri"/>
                <a:ea typeface="Yu Gothic"/>
              </a:rPr>
              <a:t>&lt;date/time&gt;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11299680"/>
            <a:ext cx="4114800" cy="649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11299680"/>
            <a:ext cx="2743200" cy="649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600" spc="-1" strike="noStrike">
                <a:solidFill>
                  <a:srgbClr val="898989"/>
                </a:solidFill>
                <a:latin typeface="Calibri"/>
                <a:ea typeface="Yu Gothic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B67B4E59-9459-495A-8F7E-C3A12ACE2B21}" type="slidenum">
              <a:rPr b="0" lang="ja-JP" sz="1600" spc="-1" strike="noStrike">
                <a:solidFill>
                  <a:srgbClr val="898989"/>
                </a:solidFill>
                <a:latin typeface="Calibri"/>
                <a:ea typeface="Yu Gothic"/>
              </a:rPr>
              <a:t>&lt;number&gt;</a:t>
            </a:fld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テキスト ボックス 4"/>
          <p:cNvSpPr/>
          <p:nvPr/>
        </p:nvSpPr>
        <p:spPr>
          <a:xfrm>
            <a:off x="374760" y="431640"/>
            <a:ext cx="113281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Yu Gothic"/>
              </a:rPr>
              <a:t>Supplementary Material 3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Yu Gothic"/>
              </a:rPr>
              <a:t>. </a:t>
            </a: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Yu Gothic"/>
              </a:rPr>
              <a:t>Smoking prevalence and lung cancer incidence rates by histological type (squamous cell carcinoma and adenocarcinoma) in Korea during 1960−2022 among men (A) and women (B)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9" name="Group 2"/>
          <p:cNvGrpSpPr/>
          <p:nvPr/>
        </p:nvGrpSpPr>
        <p:grpSpPr>
          <a:xfrm>
            <a:off x="598320" y="1519200"/>
            <a:ext cx="10958760" cy="10652040"/>
            <a:chOff x="598320" y="1519200"/>
            <a:chExt cx="10958760" cy="10652040"/>
          </a:xfrm>
        </p:grpSpPr>
        <p:sp>
          <p:nvSpPr>
            <p:cNvPr id="50" name="テキスト ボックス 4"/>
            <p:cNvSpPr/>
            <p:nvPr/>
          </p:nvSpPr>
          <p:spPr>
            <a:xfrm>
              <a:off x="607320" y="1519200"/>
              <a:ext cx="53856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Arial"/>
                  <a:ea typeface="Yu Gothic"/>
                </a:rPr>
                <a:t>A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テキスト ボックス 4"/>
            <p:cNvSpPr/>
            <p:nvPr/>
          </p:nvSpPr>
          <p:spPr>
            <a:xfrm>
              <a:off x="598320" y="6756840"/>
              <a:ext cx="53856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Arial"/>
                  <a:ea typeface="Yu Gothic"/>
                </a:rPr>
                <a:t>B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52" name="Chart 1" descr=""/>
            <p:cNvPicPr/>
            <p:nvPr/>
          </p:nvPicPr>
          <p:blipFill>
            <a:blip r:embed="rId1"/>
            <a:stretch/>
          </p:blipFill>
          <p:spPr>
            <a:xfrm>
              <a:off x="1042200" y="1542240"/>
              <a:ext cx="10514880" cy="5400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3" name="Chart 9" descr=""/>
            <p:cNvPicPr/>
            <p:nvPr/>
          </p:nvPicPr>
          <p:blipFill>
            <a:blip r:embed="rId2"/>
            <a:stretch/>
          </p:blipFill>
          <p:spPr>
            <a:xfrm>
              <a:off x="1042200" y="6771240"/>
              <a:ext cx="10514880" cy="540000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5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2-11-08T14:40:59Z</dcterms:created>
  <dc:creator>JE editorial office</dc:creator>
  <dc:description/>
  <dc:language>en-US</dc:language>
  <cp:lastModifiedBy>이제인</cp:lastModifiedBy>
  <dcterms:modified xsi:type="dcterms:W3CDTF">2026-05-28T04:14:39Z</dcterms:modified>
  <cp:revision>4</cp:revision>
  <dc:subject/>
  <dc:title>PowerPoint プレゼンテーション</dc:title>
</cp:coreProperties>
</file>